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79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2109672-86F3-B6D7-5EF4-8E96CBB921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B51238C9-4183-D243-9105-31AE8D6415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59AD2BB-74A2-07AA-163F-B377C0165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95236F6-DD29-136E-BC40-3574D492F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DDDC75F-24A6-3231-01D6-40BEECC6C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11494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95518A6-C782-6010-9676-163FF4446B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BCED8A90-1870-B764-17B2-DCF6622B4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587E6E6-B562-5792-566E-BC9BAA2ED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132E398-C073-438C-7AEF-F109B2327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F1AD915-1A86-2461-4B51-37EA9CB02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25184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AE16C139-A53D-85CF-B8E3-217B387DDA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E02380FB-DA72-63FA-EACE-1D68EF1958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1248504-1CE8-99EE-388B-B5D9C4E76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080E964-A331-2C37-527D-95C771EEF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3A71F4C-D01C-BCB8-C992-D59245C62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31951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2DA342F-05D5-32A3-6A02-5BEF37E6C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3A23DB5F-0D82-DBC2-CBC5-24C8B24003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B96B6E8-F858-8353-FF82-52B1EE058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1CC3EE0-1078-515C-BDF6-C7EACA388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7C834E9-6D8A-EF08-8D07-EF461376A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5294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E69F8FA-3932-2F4B-A431-A2979DA94D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6EC06C58-31F2-8B39-D035-D240D335E0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390532C-7A15-0064-2152-E83EA3543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553E24C-6832-A9BD-ADDD-8CDCB15A9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93AEDA7-A1EF-7DAE-BEA3-CC3CA2A96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11072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A8D8714-3510-2100-DCF3-1108554A4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9A6ED3E8-384E-148A-B12B-1B857D5A76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71B0A4A2-7BE0-6641-90F7-65322DBB91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BA70EBB9-7DFD-E6CF-AC7D-4FA5C5F48B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09911CE6-0BD7-45C3-9A1F-2913D8452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77A89982-DB07-F6A9-C1DF-3092548FA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60177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A80EEB4-D8CB-AA8B-33ED-4519BFB4F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1E40C1E-AA4A-F6A6-72F8-2B9B50196B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BF881A2A-F2DF-8609-6E0D-F96402304C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38FF73A9-4994-A561-6F17-5C5028FCEE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28BE5460-7533-FEF1-F043-FC6A611F5C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525D198F-1C9E-FAFA-74F0-9A1A6E435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57AD87F-D244-753E-C456-A4A4A04AE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14B9C4E5-5FF9-770F-2076-F893FC5AB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40174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571B73D-6794-07F3-B0D5-683D55A6C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63BF00C4-2105-DE10-8011-29A4F2885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8C3070DA-D442-CE67-2D3C-9092F5304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D64280C4-0311-8F45-6928-59F273C0C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663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40C46D64-00B4-9D6A-FBBA-9C3175F7A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71A4C9F2-80C6-6F8D-E03D-C9E65FC37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E792EFED-3BDD-4905-F729-DD405D9FD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19896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E55DB45-F948-537A-C7C7-C232CB490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DA63538-7DF6-D72E-B37C-197C2009FF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DB957471-4723-80A2-EC0B-76D5460A5B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583072C-2062-7A20-F2CB-C0A4AE229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F5945C23-4D25-CE91-4AE7-3979A731C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E82A1308-2EA5-3EC6-B9DA-A4FE6B001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14830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6D16E9C-307D-A997-4C12-B4DFF4F4A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3A304FA1-83D9-399C-D18A-BB5A3FB0D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31A42143-98BA-EEF3-079D-9414F0B66C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BC43ED4-BB97-6302-8495-B7953AAF6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2935B0B-0E72-D8D0-B2C8-CDB4134CE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637F6EA9-F45F-B2D1-E163-7CD18C7CC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1581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D392083F-AE27-0C8B-B945-54C52F76D6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4D845C4A-32F8-E50C-5E35-6C29889EF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62D6218-68F9-A789-1392-3F4EB87FCE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24151-02A5-492C-8944-D350F9E61767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48B3CA9-1F64-3F6D-090D-37B471256D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19C0E14-246C-F808-3147-B2B1A3208D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821E5-31F4-4AB7-979E-BA5320940B2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34994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1711A847-5FA5-C9CE-C1E4-C78A4FAC886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80247" y="226337"/>
            <a:ext cx="11280616" cy="6505722"/>
            <a:chOff x="1834" y="1012"/>
            <a:chExt cx="3892" cy="2348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F43DBD27-55D3-D59D-33C8-23B3203BA2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012"/>
              <a:ext cx="39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thor and year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70A7BAAE-86C0-705B-7170-FEC143823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203"/>
              <a:ext cx="96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EEG </a:t>
              </a:r>
              <a:r>
                <a:rPr kumimoji="0" lang="hu-HU" altLang="hu-HU" sz="1100" b="1" i="0" u="none" strike="noStrike" cap="none" normalizeH="0" baseline="0" dirty="0" err="1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connectivity</a:t>
              </a: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and </a:t>
              </a:r>
              <a:r>
                <a:rPr kumimoji="0" lang="hu-HU" altLang="hu-HU" sz="1100" b="1" i="0" u="none" strike="noStrike" cap="none" normalizeH="0" baseline="0" dirty="0" err="1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network</a:t>
              </a: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</a:t>
              </a:r>
              <a:r>
                <a:rPr kumimoji="0" lang="hu-HU" altLang="hu-HU" sz="1100" b="1" i="0" u="none" strike="noStrike" cap="none" normalizeH="0" baseline="0" dirty="0" err="1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analyses</a:t>
              </a:r>
              <a:endParaRPr kumimoji="0" lang="hu-HU" altLang="hu-HU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EF312376-42D0-E81B-10AC-F2F5125363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969"/>
              <a:ext cx="36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EEG </a:t>
              </a:r>
              <a:r>
                <a:rPr kumimoji="0" lang="hu-HU" altLang="hu-HU" sz="1100" b="1" i="0" u="none" strike="noStrike" cap="none" normalizeH="0" baseline="0" dirty="0" err="1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power</a:t>
              </a: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      </a:t>
              </a:r>
              <a:endParaRPr kumimoji="0" lang="hu-HU" altLang="hu-HU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C80B32F8-AA74-6FA6-C412-7A84B7D0C0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639"/>
              <a:ext cx="25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 dirty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CRS-R       </a:t>
              </a:r>
              <a:endParaRPr kumimoji="0" lang="hu-HU" altLang="hu-HU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30BF2D52-D3C5-FF4A-B554-449CB0886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682"/>
              <a:ext cx="66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Random effects model (HK)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8C4B31B9-4816-BA75-D724-47A7BA275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352"/>
              <a:ext cx="66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Random effects model (HK)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20786626-B9C1-55F6-6B56-0DB21F96F3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3021"/>
              <a:ext cx="66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Random effects model (HK)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D4F3C12B-4947-881C-507A-28CD99D5D4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786"/>
              <a:ext cx="33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Heterogeneity: 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EA21EAED-134C-DC15-D75C-1AC7AB3E4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1786"/>
              <a:ext cx="1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1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I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C1E1DC2F-27F0-4F9F-CCFE-D0B7901A6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" y="1772"/>
              <a:ext cx="23" cy="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90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DFF520E7-1442-0543-4A3E-4BB5DCEFD9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3" y="1786"/>
              <a:ext cx="38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= 36% [0%; 78%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CA90C764-C9B6-5DFF-D535-21DF27AB30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456"/>
              <a:ext cx="33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Heterogeneity: 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54AF8A1D-D4A3-E798-F79D-1CCE1795A5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2456"/>
              <a:ext cx="1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1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I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275A1060-82C6-BAB1-39BB-7297A858B3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" y="2442"/>
              <a:ext cx="23" cy="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90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D459ACE8-E537-0542-3673-E7263B0CE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3" y="2456"/>
              <a:ext cx="36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= 0% [0%; 90%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35DDD730-E6A3-DBD0-B17B-87548455F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3126"/>
              <a:ext cx="33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Heterogeneity: 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35D1DA0D-C81D-5186-88C6-7CAF750DD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3126"/>
              <a:ext cx="1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1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I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98E7A036-839C-271C-C0A3-AF90BCDE0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" y="3112"/>
              <a:ext cx="23" cy="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90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F4B8F8AE-7B4B-BAFC-C5C4-371DC00BC7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3" y="3126"/>
              <a:ext cx="36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A9A9A9"/>
                  </a:solidFill>
                  <a:effectLst/>
                  <a:latin typeface="Helvetica" panose="020B0604020202020204" pitchFamily="34" charset="0"/>
                </a:rPr>
                <a:t> = 0% [0%; 90%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7B20CADF-79C9-BB86-53BE-16449F8A63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301"/>
              <a:ext cx="33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itt et al., 2014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6EDC5D87-4EDD-F572-50F1-35E4EFF54B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397"/>
              <a:ext cx="44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Chennu et al., 201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E2B12E30-7A13-93C4-4A3F-48ADDEF64D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493"/>
              <a:ext cx="41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efan et al., 201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16EE4DB7-4059-AFE4-D23B-503F68C9E5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1588"/>
              <a:ext cx="33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ai et al., 201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5A519B63-5ED3-A279-677F-3C39D9AA0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067"/>
              <a:ext cx="41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efan et al., 201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4EEB6DFF-C294-F93E-7D78-0119AD8CEC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163"/>
              <a:ext cx="33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itt et al., 2014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68A95AC3-824B-7E94-BD84-6B763BA0F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258"/>
              <a:ext cx="44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Chennu et al., 201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14208D3F-6B47-777A-6EA0-B1AC01D041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737"/>
              <a:ext cx="41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efan et al., 201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6AA2D719-E554-738F-98B2-F0A7BD993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833"/>
              <a:ext cx="44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Chennu et al., 201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94E3B55F-FD86-68E7-DAC1-1F2FB1443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4" y="2929"/>
              <a:ext cx="33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ai et al., 201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E678108C-83BA-25B0-9729-A138B66F8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8" y="1012"/>
              <a:ext cx="3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780F473F-C6A2-63D3-1F33-155361ABE6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301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7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4B37D9A0-82E6-8BE0-437F-9350FBEF70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39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8D13770C-F572-68C8-2433-A7CCBC1539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49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F73C4E3D-1E71-35D6-9573-D27ED5BE8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588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5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9A3C23E4-0D1F-DDE7-8E52-9B9D6C119B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06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B06138B5-1895-B5A7-815B-FE74CF616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16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7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F5AC47FF-9A44-9824-BAA7-A0F5268842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258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FF5B3CD2-62D1-616D-11F2-D34721F7BA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73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9591A3FB-4104-7DC8-DCB9-16B16B3A4F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83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0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CEB79FC1-6988-34C3-FC80-85CFF21352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929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5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A345B92C-8EE9-273E-19B2-DE902607D9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6" y="1012"/>
              <a:ext cx="24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recovered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87E9CD9E-5E08-D205-DAF7-42E2E4E17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1301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ED2AEE4A-5EAA-E8DE-6232-BB2C2CB3B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139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D5253092-CBDB-0F82-5032-8588A534B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149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6F0D73D9-FA63-5F81-37C7-A1A39B4434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9" y="1588"/>
              <a:ext cx="2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DEC9E0CB-9684-CE92-6C19-AEA1A11513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206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FE843EDA-9E44-1952-25FD-1A5810CB9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216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760930BE-537D-9AC5-7E45-3BD7872EE9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2258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1839E59C-4A9B-E222-E823-D1FAAE4598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273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666AD5BC-E561-7848-1DC9-B961AC21BC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" y="283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AA25A17B-FDDA-6EF2-7728-914BA34CE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9" y="2929"/>
              <a:ext cx="2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8657BF26-CD78-32D0-4EFD-B64AC819E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1" y="1012"/>
              <a:ext cx="33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ot recovered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CA761751-F884-7B74-18C2-6C9900772D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1301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4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8319C838-5D6A-84E4-6CD2-1926A0FC9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139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635A0082-A565-0ACE-FB82-802D84B43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149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5B767AAA-6FA4-DB5B-BACF-2899FF2CD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1588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45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7B543D73-28C9-FDDA-810F-5B964876D4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06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7B1DAA4F-B318-3312-36DC-13C86B385D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16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4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368F9826-6F36-8F03-9AF5-C00AA7645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258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E322ED8F-5E84-3B34-B14E-7FD1490D3B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737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8FD5E645-6E62-83FD-6DE4-6DFD1D2AFA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833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6C0D7C0A-64C5-9605-9114-448E394F24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0" y="2929"/>
              <a:ext cx="57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44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53029AC9-D966-51F8-0E19-E7F11AD0D9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" y="3208"/>
              <a:ext cx="104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1" name="Line 68">
              <a:extLst>
                <a:ext uri="{FF2B5EF4-FFF2-40B4-BE49-F238E27FC236}">
                  <a16:creationId xmlns:a16="http://schemas.microsoft.com/office/drawing/2014/main" id="{23A8B10F-0C7D-3100-0CE5-B71467AF93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2" name="Line 69">
              <a:extLst>
                <a:ext uri="{FF2B5EF4-FFF2-40B4-BE49-F238E27FC236}">
                  <a16:creationId xmlns:a16="http://schemas.microsoft.com/office/drawing/2014/main" id="{10F0DBE6-A64F-11DC-52D2-0047BE5201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62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3" name="Line 70">
              <a:extLst>
                <a:ext uri="{FF2B5EF4-FFF2-40B4-BE49-F238E27FC236}">
                  <a16:creationId xmlns:a16="http://schemas.microsoft.com/office/drawing/2014/main" id="{216BC266-0630-84A8-CBFC-9AF6115BA1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6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4" name="Line 71">
              <a:extLst>
                <a:ext uri="{FF2B5EF4-FFF2-40B4-BE49-F238E27FC236}">
                  <a16:creationId xmlns:a16="http://schemas.microsoft.com/office/drawing/2014/main" id="{35FAD9A1-24CB-3221-BE65-0D7357B11A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10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5" name="Line 72">
              <a:extLst>
                <a:ext uri="{FF2B5EF4-FFF2-40B4-BE49-F238E27FC236}">
                  <a16:creationId xmlns:a16="http://schemas.microsoft.com/office/drawing/2014/main" id="{4F9D9F83-13A3-94B1-985B-6C6662C9C6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4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6" name="Line 73">
              <a:extLst>
                <a:ext uri="{FF2B5EF4-FFF2-40B4-BE49-F238E27FC236}">
                  <a16:creationId xmlns:a16="http://schemas.microsoft.com/office/drawing/2014/main" id="{4C167CDF-4DB7-B665-D663-2A072C958E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8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B5191F32-5684-73C1-D304-71719DB8D0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1" y="3208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DB65F1ED-4AA7-0FC5-794F-BD1650C62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4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A6C5FBA8-3E8D-B453-5791-5729BAB202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4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5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A9F9E19F-49C6-1116-E28A-DEBEE87B68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8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DE9F76C3-CF5E-ECFB-F4FE-25CED4BD18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2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D245DA85-526D-BEA1-2A38-1992ECB864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6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93E7E22F-F2A1-E201-CCE7-815A8C05EC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2" y="3299"/>
              <a:ext cx="7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0735D7EC-22A9-B1A4-E3C1-8C7B17D3BF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" y="3299"/>
              <a:ext cx="2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0E2D8265-F5F1-4FDB-6DC7-0FC93BFBE3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" y="1012"/>
              <a:ext cx="11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C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Freeform 83">
              <a:extLst>
                <a:ext uri="{FF2B5EF4-FFF2-40B4-BE49-F238E27FC236}">
                  <a16:creationId xmlns:a16="http://schemas.microsoft.com/office/drawing/2014/main" id="{FE5CE0C8-2B8F-553C-4BA0-AA2811BDF6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727" y="1701"/>
              <a:ext cx="291" cy="45"/>
            </a:xfrm>
            <a:custGeom>
              <a:avLst/>
              <a:gdLst>
                <a:gd name="T0" fmla="*/ 0 w 291"/>
                <a:gd name="T1" fmla="*/ 22 h 45"/>
                <a:gd name="T2" fmla="*/ 146 w 291"/>
                <a:gd name="T3" fmla="*/ 0 h 45"/>
                <a:gd name="T4" fmla="*/ 291 w 291"/>
                <a:gd name="T5" fmla="*/ 22 h 45"/>
                <a:gd name="T6" fmla="*/ 146 w 291"/>
                <a:gd name="T7" fmla="*/ 45 h 45"/>
                <a:gd name="T8" fmla="*/ 0 w 291"/>
                <a:gd name="T9" fmla="*/ 22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1" h="45">
                  <a:moveTo>
                    <a:pt x="0" y="22"/>
                  </a:moveTo>
                  <a:lnTo>
                    <a:pt x="146" y="0"/>
                  </a:lnTo>
                  <a:lnTo>
                    <a:pt x="291" y="22"/>
                  </a:lnTo>
                  <a:lnTo>
                    <a:pt x="146" y="45"/>
                  </a:lnTo>
                  <a:lnTo>
                    <a:pt x="0" y="22"/>
                  </a:lnTo>
                  <a:close/>
                </a:path>
              </a:pathLst>
            </a:custGeom>
            <a:solidFill>
              <a:srgbClr val="0000FF"/>
            </a:solidFill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D89E7AA7-C2F0-99CD-7B3D-789BE7E5EEA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13" y="2371"/>
              <a:ext cx="153" cy="45"/>
            </a:xfrm>
            <a:custGeom>
              <a:avLst/>
              <a:gdLst>
                <a:gd name="T0" fmla="*/ 0 w 153"/>
                <a:gd name="T1" fmla="*/ 23 h 45"/>
                <a:gd name="T2" fmla="*/ 77 w 153"/>
                <a:gd name="T3" fmla="*/ 0 h 45"/>
                <a:gd name="T4" fmla="*/ 153 w 153"/>
                <a:gd name="T5" fmla="*/ 23 h 45"/>
                <a:gd name="T6" fmla="*/ 77 w 153"/>
                <a:gd name="T7" fmla="*/ 45 h 45"/>
                <a:gd name="T8" fmla="*/ 0 w 153"/>
                <a:gd name="T9" fmla="*/ 23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53" h="45">
                  <a:moveTo>
                    <a:pt x="0" y="23"/>
                  </a:moveTo>
                  <a:lnTo>
                    <a:pt x="77" y="0"/>
                  </a:lnTo>
                  <a:lnTo>
                    <a:pt x="153" y="23"/>
                  </a:lnTo>
                  <a:lnTo>
                    <a:pt x="77" y="45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FF"/>
            </a:solidFill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4AD64F47-1388-01E7-94D2-03CF0253E8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31" y="3042"/>
              <a:ext cx="270" cy="44"/>
            </a:xfrm>
            <a:custGeom>
              <a:avLst/>
              <a:gdLst>
                <a:gd name="T0" fmla="*/ 0 w 270"/>
                <a:gd name="T1" fmla="*/ 22 h 44"/>
                <a:gd name="T2" fmla="*/ 134 w 270"/>
                <a:gd name="T3" fmla="*/ 0 h 44"/>
                <a:gd name="T4" fmla="*/ 270 w 270"/>
                <a:gd name="T5" fmla="*/ 22 h 44"/>
                <a:gd name="T6" fmla="*/ 134 w 270"/>
                <a:gd name="T7" fmla="*/ 44 h 44"/>
                <a:gd name="T8" fmla="*/ 0 w 270"/>
                <a:gd name="T9" fmla="*/ 22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70" h="44">
                  <a:moveTo>
                    <a:pt x="0" y="22"/>
                  </a:moveTo>
                  <a:lnTo>
                    <a:pt x="134" y="0"/>
                  </a:lnTo>
                  <a:lnTo>
                    <a:pt x="270" y="22"/>
                  </a:lnTo>
                  <a:lnTo>
                    <a:pt x="134" y="44"/>
                  </a:lnTo>
                  <a:lnTo>
                    <a:pt x="0" y="22"/>
                  </a:lnTo>
                  <a:close/>
                </a:path>
              </a:pathLst>
            </a:custGeom>
            <a:solidFill>
              <a:srgbClr val="0000FF"/>
            </a:solidFill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1275530E-8A67-7081-69B5-1606EB87E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8" y="1313"/>
              <a:ext cx="54" cy="55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id="{F69FB9EF-2C86-F011-9CCA-ABC196F797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5" y="1331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C3F4C160-C00C-DA30-90C0-BF5F80561A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37" y="1340"/>
              <a:ext cx="47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1DB66579-BA25-E10C-94DB-59C8BD9B3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1" y="1406"/>
              <a:ext cx="62" cy="61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id="{FBB8AFC6-BF5D-9A41-700B-EA85F029E7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1" y="1427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4" name="Line 91">
              <a:extLst>
                <a:ext uri="{FF2B5EF4-FFF2-40B4-BE49-F238E27FC236}">
                  <a16:creationId xmlns:a16="http://schemas.microsoft.com/office/drawing/2014/main" id="{D3EABF3A-12CD-F2FB-BD91-F8060E4741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8" y="1436"/>
              <a:ext cx="40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5" name="Rectangle 92">
              <a:extLst>
                <a:ext uri="{FF2B5EF4-FFF2-40B4-BE49-F238E27FC236}">
                  <a16:creationId xmlns:a16="http://schemas.microsoft.com/office/drawing/2014/main" id="{7355229A-FD64-A8B2-21DF-C5D22933C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5" y="1508"/>
              <a:ext cx="46" cy="48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6" name="Line 93">
              <a:extLst>
                <a:ext uri="{FF2B5EF4-FFF2-40B4-BE49-F238E27FC236}">
                  <a16:creationId xmlns:a16="http://schemas.microsoft.com/office/drawing/2014/main" id="{464A992F-5A87-9641-B647-6E0E055003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19" y="1522"/>
              <a:ext cx="0" cy="2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1A4415AB-0C5B-4221-344C-8A425F013E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3" y="1532"/>
              <a:ext cx="57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290604B5-2B1B-C3C3-2FC7-6211AD06C1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" y="1596"/>
              <a:ext cx="62" cy="64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4E90336E-DFD0-E4B3-51D8-64C462245C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10" y="1618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0" name="Line 97">
              <a:extLst>
                <a:ext uri="{FF2B5EF4-FFF2-40B4-BE49-F238E27FC236}">
                  <a16:creationId xmlns:a16="http://schemas.microsoft.com/office/drawing/2014/main" id="{47C1008F-B3DD-D279-63E8-9375FC1BAE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0" y="1628"/>
              <a:ext cx="39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D943037C-AC85-0256-837B-D93B5AB4DE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1" y="2081"/>
              <a:ext cx="49" cy="51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2" name="Line 99">
              <a:extLst>
                <a:ext uri="{FF2B5EF4-FFF2-40B4-BE49-F238E27FC236}">
                  <a16:creationId xmlns:a16="http://schemas.microsoft.com/office/drawing/2014/main" id="{38DEDC7A-4AE0-D1A1-A74B-FD10199D19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5" y="2097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3" name="Line 100">
              <a:extLst>
                <a:ext uri="{FF2B5EF4-FFF2-40B4-BE49-F238E27FC236}">
                  <a16:creationId xmlns:a16="http://schemas.microsoft.com/office/drawing/2014/main" id="{136117A6-D55E-7A2D-E57B-DEBBADFA99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2" y="2106"/>
              <a:ext cx="68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B56DCFC1-74D5-0FED-E41B-C9F6FB22F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2" y="2169"/>
              <a:ext cx="69" cy="6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5" name="Line 102">
              <a:extLst>
                <a:ext uri="{FF2B5EF4-FFF2-40B4-BE49-F238E27FC236}">
                  <a16:creationId xmlns:a16="http://schemas.microsoft.com/office/drawing/2014/main" id="{E5432581-39BB-D73E-80A0-ED1CF81BEC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27" y="2193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6" name="Line 103">
              <a:extLst>
                <a:ext uri="{FF2B5EF4-FFF2-40B4-BE49-F238E27FC236}">
                  <a16:creationId xmlns:a16="http://schemas.microsoft.com/office/drawing/2014/main" id="{E89AD35F-98CE-7481-A059-CEE801950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8" y="2202"/>
              <a:ext cx="47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ECB76458-7A01-AC15-EFB4-787B5B3507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5" y="2260"/>
              <a:ext cx="77" cy="76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8" name="Line 105">
              <a:extLst>
                <a:ext uri="{FF2B5EF4-FFF2-40B4-BE49-F238E27FC236}">
                  <a16:creationId xmlns:a16="http://schemas.microsoft.com/office/drawing/2014/main" id="{9F5F965D-E2DC-9C99-D3A6-0364087A64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4" y="2288"/>
              <a:ext cx="0" cy="2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09" name="Line 106">
              <a:extLst>
                <a:ext uri="{FF2B5EF4-FFF2-40B4-BE49-F238E27FC236}">
                  <a16:creationId xmlns:a16="http://schemas.microsoft.com/office/drawing/2014/main" id="{9BF11730-7E38-EB38-2C8F-0AB240E51C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6" y="2298"/>
              <a:ext cx="41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47EE7690-AD14-2525-C2F2-3248A15D90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2" y="2750"/>
              <a:ext cx="54" cy="54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1" name="Line 108">
              <a:extLst>
                <a:ext uri="{FF2B5EF4-FFF2-40B4-BE49-F238E27FC236}">
                  <a16:creationId xmlns:a16="http://schemas.microsoft.com/office/drawing/2014/main" id="{79F7C47E-E72C-1F10-ED6C-0D14EAC727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19" y="2767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2" name="Line 109">
              <a:extLst>
                <a:ext uri="{FF2B5EF4-FFF2-40B4-BE49-F238E27FC236}">
                  <a16:creationId xmlns:a16="http://schemas.microsoft.com/office/drawing/2014/main" id="{D6AD32C8-868C-F833-6C61-1ADA8F6FB4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0" y="2777"/>
              <a:ext cx="69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3" name="Rectangle 110">
              <a:extLst>
                <a:ext uri="{FF2B5EF4-FFF2-40B4-BE49-F238E27FC236}">
                  <a16:creationId xmlns:a16="http://schemas.microsoft.com/office/drawing/2014/main" id="{3A43056C-3785-E9C9-ABDC-7936AC191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3" y="2834"/>
              <a:ext cx="75" cy="7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4" name="Line 111">
              <a:extLst>
                <a:ext uri="{FF2B5EF4-FFF2-40B4-BE49-F238E27FC236}">
                  <a16:creationId xmlns:a16="http://schemas.microsoft.com/office/drawing/2014/main" id="{EE391FE8-295F-A94F-C0F8-646ABA3BAB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40" y="2863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5" name="Line 112">
              <a:extLst>
                <a:ext uri="{FF2B5EF4-FFF2-40B4-BE49-F238E27FC236}">
                  <a16:creationId xmlns:a16="http://schemas.microsoft.com/office/drawing/2014/main" id="{F172FB56-494D-CE2A-5C3C-3E2B5235E6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02" y="2872"/>
              <a:ext cx="47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6" name="Rectangle 113">
              <a:extLst>
                <a:ext uri="{FF2B5EF4-FFF2-40B4-BE49-F238E27FC236}">
                  <a16:creationId xmlns:a16="http://schemas.microsoft.com/office/drawing/2014/main" id="{33CD2005-7535-383F-B09A-CA2254363D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8" y="2935"/>
              <a:ext cx="65" cy="6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7" name="Line 114">
              <a:extLst>
                <a:ext uri="{FF2B5EF4-FFF2-40B4-BE49-F238E27FC236}">
                  <a16:creationId xmlns:a16="http://schemas.microsoft.com/office/drawing/2014/main" id="{425DC801-AD86-1CCF-169C-DBD8A744A2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1" y="2959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8" name="Line 115">
              <a:extLst>
                <a:ext uri="{FF2B5EF4-FFF2-40B4-BE49-F238E27FC236}">
                  <a16:creationId xmlns:a16="http://schemas.microsoft.com/office/drawing/2014/main" id="{E2BABAE5-7DBB-0184-7CA1-E9ABD6C78D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2" y="2968"/>
              <a:ext cx="55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2800"/>
            </a:p>
          </p:txBody>
        </p:sp>
        <p:sp>
          <p:nvSpPr>
            <p:cNvPr id="119" name="Rectangle 116">
              <a:extLst>
                <a:ext uri="{FF2B5EF4-FFF2-40B4-BE49-F238E27FC236}">
                  <a16:creationId xmlns:a16="http://schemas.microsoft.com/office/drawing/2014/main" id="{FB5400B6-1BFE-302D-2AB3-C281946AF8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2" y="1012"/>
              <a:ext cx="111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C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7">
              <a:extLst>
                <a:ext uri="{FF2B5EF4-FFF2-40B4-BE49-F238E27FC236}">
                  <a16:creationId xmlns:a16="http://schemas.microsoft.com/office/drawing/2014/main" id="{9EBD1C39-3EA1-F5B1-BCDD-DBDCD71EFA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5" y="1682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9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18">
              <a:extLst>
                <a:ext uri="{FF2B5EF4-FFF2-40B4-BE49-F238E27FC236}">
                  <a16:creationId xmlns:a16="http://schemas.microsoft.com/office/drawing/2014/main" id="{050E5553-F791-D3F0-1EAC-7123518EC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5" y="2352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5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A2D221FD-9F0A-A69D-C303-E0C1575DE9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5" y="3021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0">
              <a:extLst>
                <a:ext uri="{FF2B5EF4-FFF2-40B4-BE49-F238E27FC236}">
                  <a16:creationId xmlns:a16="http://schemas.microsoft.com/office/drawing/2014/main" id="{07475E4C-FAB2-0939-DAD7-F430D86C5D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1301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8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0D0DF448-FDCE-742F-7738-6D290AE18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1397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122">
              <a:extLst>
                <a:ext uri="{FF2B5EF4-FFF2-40B4-BE49-F238E27FC236}">
                  <a16:creationId xmlns:a16="http://schemas.microsoft.com/office/drawing/2014/main" id="{2D9B0111-11D4-4F23-B344-687B4F846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1493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82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23">
              <a:extLst>
                <a:ext uri="{FF2B5EF4-FFF2-40B4-BE49-F238E27FC236}">
                  <a16:creationId xmlns:a16="http://schemas.microsoft.com/office/drawing/2014/main" id="{B01F9261-B4E4-4C4E-1820-46A0C81CC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1588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8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24">
              <a:extLst>
                <a:ext uri="{FF2B5EF4-FFF2-40B4-BE49-F238E27FC236}">
                  <a16:creationId xmlns:a16="http://schemas.microsoft.com/office/drawing/2014/main" id="{4A3C20A2-244B-992A-4615-9412C08B7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067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8</a:t>
              </a:r>
              <a:endParaRPr kumimoji="0" lang="hu-HU" altLang="hu-HU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125">
              <a:extLst>
                <a:ext uri="{FF2B5EF4-FFF2-40B4-BE49-F238E27FC236}">
                  <a16:creationId xmlns:a16="http://schemas.microsoft.com/office/drawing/2014/main" id="{21F35282-EBA6-D529-B3F4-7581815D1D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163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1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Rectangle 126">
              <a:extLst>
                <a:ext uri="{FF2B5EF4-FFF2-40B4-BE49-F238E27FC236}">
                  <a16:creationId xmlns:a16="http://schemas.microsoft.com/office/drawing/2014/main" id="{C6DA63AE-29EB-B3DC-898D-7C8E829EA2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258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6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" name="Rectangle 127">
              <a:extLst>
                <a:ext uri="{FF2B5EF4-FFF2-40B4-BE49-F238E27FC236}">
                  <a16:creationId xmlns:a16="http://schemas.microsoft.com/office/drawing/2014/main" id="{FCA4379F-85EB-1B1B-9226-791B156181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737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5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128">
              <a:extLst>
                <a:ext uri="{FF2B5EF4-FFF2-40B4-BE49-F238E27FC236}">
                  <a16:creationId xmlns:a16="http://schemas.microsoft.com/office/drawing/2014/main" id="{C90DE9D0-5B07-8C11-5BAA-2047E89DC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833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6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Rectangle 129">
              <a:extLst>
                <a:ext uri="{FF2B5EF4-FFF2-40B4-BE49-F238E27FC236}">
                  <a16:creationId xmlns:a16="http://schemas.microsoft.com/office/drawing/2014/main" id="{BAA6F9E2-88D8-EB6A-E50E-B05FE7BF63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929"/>
              <a:ext cx="99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7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Rectangle 130">
              <a:extLst>
                <a:ext uri="{FF2B5EF4-FFF2-40B4-BE49-F238E27FC236}">
                  <a16:creationId xmlns:a16="http://schemas.microsoft.com/office/drawing/2014/main" id="{762D4471-42D3-C656-B9F5-788BBB872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6" y="1012"/>
              <a:ext cx="170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95%-CI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31">
              <a:extLst>
                <a:ext uri="{FF2B5EF4-FFF2-40B4-BE49-F238E27FC236}">
                  <a16:creationId xmlns:a16="http://schemas.microsoft.com/office/drawing/2014/main" id="{730BABD4-1985-5F58-C411-67C4D6811E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" y="1682"/>
              <a:ext cx="26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71; 0.88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132">
              <a:extLst>
                <a:ext uri="{FF2B5EF4-FFF2-40B4-BE49-F238E27FC236}">
                  <a16:creationId xmlns:a16="http://schemas.microsoft.com/office/drawing/2014/main" id="{E80547F2-EDF5-A81D-460F-D79911B9A3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" y="2352"/>
              <a:ext cx="26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70; 0.79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133">
              <a:extLst>
                <a:ext uri="{FF2B5EF4-FFF2-40B4-BE49-F238E27FC236}">
                  <a16:creationId xmlns:a16="http://schemas.microsoft.com/office/drawing/2014/main" id="{D1C18757-DC5A-5A92-F8BF-B10CB7788D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" y="3021"/>
              <a:ext cx="262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60; 0.75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134">
              <a:extLst>
                <a:ext uri="{FF2B5EF4-FFF2-40B4-BE49-F238E27FC236}">
                  <a16:creationId xmlns:a16="http://schemas.microsoft.com/office/drawing/2014/main" id="{E952154E-C016-C4CD-DAAB-FE402461BE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1301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54; 0.82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5">
              <a:extLst>
                <a:ext uri="{FF2B5EF4-FFF2-40B4-BE49-F238E27FC236}">
                  <a16:creationId xmlns:a16="http://schemas.microsoft.com/office/drawing/2014/main" id="{43509C7E-D3DE-AABF-781D-A4652CB168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1397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65; 0.89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36">
              <a:extLst>
                <a:ext uri="{FF2B5EF4-FFF2-40B4-BE49-F238E27FC236}">
                  <a16:creationId xmlns:a16="http://schemas.microsoft.com/office/drawing/2014/main" id="{EDC83459-786E-41DC-FD9F-038A1BF5D9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1493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66; 0.98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37">
              <a:extLst>
                <a:ext uri="{FF2B5EF4-FFF2-40B4-BE49-F238E27FC236}">
                  <a16:creationId xmlns:a16="http://schemas.microsoft.com/office/drawing/2014/main" id="{736B9D61-9EAF-EB05-F007-F41DD50710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1588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76; 0.99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138">
              <a:extLst>
                <a:ext uri="{FF2B5EF4-FFF2-40B4-BE49-F238E27FC236}">
                  <a16:creationId xmlns:a16="http://schemas.microsoft.com/office/drawing/2014/main" id="{679CA08C-9743-C781-6238-AD2395BF28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067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48; 0.88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39">
              <a:extLst>
                <a:ext uri="{FF2B5EF4-FFF2-40B4-BE49-F238E27FC236}">
                  <a16:creationId xmlns:a16="http://schemas.microsoft.com/office/drawing/2014/main" id="{18BDC95A-BA0F-727A-DD17-0061851924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163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57; 0.85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40">
              <a:extLst>
                <a:ext uri="{FF2B5EF4-FFF2-40B4-BE49-F238E27FC236}">
                  <a16:creationId xmlns:a16="http://schemas.microsoft.com/office/drawing/2014/main" id="{1803C1FD-FFA3-C60C-96A2-28570C8D6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258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64; 0.88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41">
              <a:extLst>
                <a:ext uri="{FF2B5EF4-FFF2-40B4-BE49-F238E27FC236}">
                  <a16:creationId xmlns:a16="http://schemas.microsoft.com/office/drawing/2014/main" id="{EA5D5CBA-25C9-7EBE-4FE6-116B8063F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737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45; 0.85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142">
              <a:extLst>
                <a:ext uri="{FF2B5EF4-FFF2-40B4-BE49-F238E27FC236}">
                  <a16:creationId xmlns:a16="http://schemas.microsoft.com/office/drawing/2014/main" id="{BF9F93A0-B41C-CC0C-B9C6-6AEF343FE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833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52; 0.80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143">
              <a:extLst>
                <a:ext uri="{FF2B5EF4-FFF2-40B4-BE49-F238E27FC236}">
                  <a16:creationId xmlns:a16="http://schemas.microsoft.com/office/drawing/2014/main" id="{3FD6FB61-9B42-1EF4-A275-DCAC9CCDC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" y="2929"/>
              <a:ext cx="253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61; 0.93]</a:t>
              </a:r>
              <a:endParaRPr kumimoji="0" lang="hu-HU" altLang="hu-HU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52691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42</Words>
  <Application>Microsoft Office PowerPoint</Application>
  <PresentationFormat>Szélesvásznú</PresentationFormat>
  <Paragraphs>98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anuta Szirmai</dc:creator>
  <cp:lastModifiedBy>Danuta Szirmai</cp:lastModifiedBy>
  <cp:revision>1</cp:revision>
  <dcterms:created xsi:type="dcterms:W3CDTF">2023-07-20T08:47:37Z</dcterms:created>
  <dcterms:modified xsi:type="dcterms:W3CDTF">2023-07-20T09:10:33Z</dcterms:modified>
</cp:coreProperties>
</file>